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81" autoAdjust="0"/>
    <p:restoredTop sz="94477"/>
  </p:normalViewPr>
  <p:slideViewPr>
    <p:cSldViewPr snapToGrid="0" snapToObjects="1">
      <p:cViewPr>
        <p:scale>
          <a:sx n="150" d="100"/>
          <a:sy n="150" d="100"/>
        </p:scale>
        <p:origin x="1416" y="-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EBD326-E2BF-4C88-A7E1-669C1E25CA39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3539EE-F22F-403B-A088-7A3BAA9271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52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362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42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657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053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644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529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7119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969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435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010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1210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56D04-9752-E84C-8FF9-145E4B6BE48F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B65026-B7BB-624A-8451-8A104A026C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251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8061907"/>
              </p:ext>
            </p:extLst>
          </p:nvPr>
        </p:nvGraphicFramePr>
        <p:xfrm>
          <a:off x="266699" y="685799"/>
          <a:ext cx="5981701" cy="316048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5518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6132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61325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412788">
                <a:tc row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Blood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glucose</a:t>
                      </a:r>
                      <a:b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</a:b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(mg/</a:t>
                      </a:r>
                      <a:r>
                        <a:rPr lang="en-US" sz="1200" kern="100" dirty="0" err="1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dL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Long-term group: first 5 times administration of </a:t>
                      </a:r>
                      <a:r>
                        <a:rPr lang="en-US" altLang="ja-JP" sz="1200" kern="100" dirty="0" smtClean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nsulin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U)</a:t>
                      </a: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Long-term group: n</a:t>
                      </a:r>
                      <a:r>
                        <a:rPr lang="en-US" sz="1200" kern="100" dirty="0" smtClean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ext 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5 times administration of </a:t>
                      </a:r>
                      <a:r>
                        <a:rPr lang="en-US" sz="1200" kern="100" dirty="0" smtClean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nsulin 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U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9252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Short-term</a:t>
                      </a:r>
                      <a:r>
                        <a:rPr lang="en-US" altLang="ja-JP" sz="1200" kern="1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 group: 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administration of </a:t>
                      </a:r>
                      <a:r>
                        <a:rPr lang="en-US" altLang="ja-JP" sz="1200" kern="100" dirty="0" smtClean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nsulin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IU)</a:t>
                      </a: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600</a:t>
                      </a:r>
                      <a:r>
                        <a:rPr 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≦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2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3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550-59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1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2.5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500-54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MS PGothic" charset="-128"/>
                        <a:ea typeface="MS PGothic" charset="-128"/>
                        <a:cs typeface="MS PGothic" charset="-128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450-49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2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400-44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8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MS PGothic" charset="-128"/>
                        <a:ea typeface="MS PGothic" charset="-128"/>
                        <a:cs typeface="MS PGothic" charset="-128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350-39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7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.5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300-34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6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MS PGothic" charset="-128"/>
                        <a:ea typeface="MS PGothic" charset="-128"/>
                        <a:cs typeface="MS PGothic" charset="-128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250-29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5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200-24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4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MS PGothic" charset="-128"/>
                        <a:ea typeface="MS PGothic" charset="-128"/>
                        <a:cs typeface="MS PGothic" charset="-128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50-19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3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0.5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00-149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2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MS PGothic" charset="-128"/>
                        <a:ea typeface="MS PGothic" charset="-128"/>
                        <a:cs typeface="MS PGothic" charset="-128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9626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99</a:t>
                      </a:r>
                      <a:endParaRPr lang="ja-JP" alt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S PGothic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PGothic" charset="-128"/>
                        <a:cs typeface="Arial" panose="020B0604020202020204" pitchFamily="34" charset="0"/>
                      </a:endParaRPr>
                    </a:p>
                  </a:txBody>
                  <a:tcPr marL="99060" marR="9906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77305" y="267788"/>
            <a:ext cx="2937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le 1: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sliding </a:t>
            </a:r>
            <a:r>
              <a:rPr lang="en-US" altLang="ja-JP" sz="1200" smtClean="0">
                <a:latin typeface="Arial" panose="020B0604020202020204" pitchFamily="34" charset="0"/>
                <a:cs typeface="Arial" panose="020B0604020202020204" pitchFamily="34" charset="0"/>
              </a:rPr>
              <a:t>scal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3012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77304" y="741685"/>
            <a:ext cx="60710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le 2: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eoperative</a:t>
            </a:r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ight change in each group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6232513"/>
              </p:ext>
            </p:extLst>
          </p:nvPr>
        </p:nvGraphicFramePr>
        <p:xfrm>
          <a:off x="257584" y="1178265"/>
          <a:ext cx="6164987" cy="17411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52282">
                  <a:extLst>
                    <a:ext uri="{9D8B030D-6E8A-4147-A177-3AD203B41FA5}">
                      <a16:colId xmlns:a16="http://schemas.microsoft.com/office/drawing/2014/main" xmlns="" val="2537526748"/>
                    </a:ext>
                  </a:extLst>
                </a:gridCol>
                <a:gridCol w="1430093">
                  <a:extLst>
                    <a:ext uri="{9D8B030D-6E8A-4147-A177-3AD203B41FA5}">
                      <a16:colId xmlns:a16="http://schemas.microsoft.com/office/drawing/2014/main" xmlns="" val="2826040909"/>
                    </a:ext>
                  </a:extLst>
                </a:gridCol>
                <a:gridCol w="1536398">
                  <a:extLst>
                    <a:ext uri="{9D8B030D-6E8A-4147-A177-3AD203B41FA5}">
                      <a16:colId xmlns:a16="http://schemas.microsoft.com/office/drawing/2014/main" xmlns="" val="1379018473"/>
                    </a:ext>
                  </a:extLst>
                </a:gridCol>
                <a:gridCol w="1246214">
                  <a:extLst>
                    <a:ext uri="{9D8B030D-6E8A-4147-A177-3AD203B41FA5}">
                      <a16:colId xmlns:a16="http://schemas.microsoft.com/office/drawing/2014/main" xmlns="" val="1381929165"/>
                    </a:ext>
                  </a:extLst>
                </a:gridCol>
              </a:tblGrid>
              <a:tr h="43076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Body weight (g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days</a:t>
                      </a:r>
                      <a:r>
                        <a:rPr lang="en-US" sz="1200" b="0" kern="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</a:t>
                      </a: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ore </a:t>
                      </a:r>
                      <a:endParaRPr lang="en-US" sz="1200" b="0" kern="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peration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</a:t>
                      </a:r>
                      <a:r>
                        <a:rPr lang="en-US" sz="1200" b="0" kern="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y of</a:t>
                      </a:r>
                      <a:endParaRPr lang="en-US" sz="1200" b="0" kern="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on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84786750"/>
                  </a:ext>
                </a:extLst>
              </a:tr>
              <a:tr h="32758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 [</a:t>
                      </a: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5-26.3</a:t>
                      </a: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4 [</a:t>
                      </a: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5-27.7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4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94979208"/>
                  </a:ext>
                </a:extLst>
              </a:tr>
              <a:tr h="32758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rt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4 [24.2-27.2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3 [24.7-27.5</a:t>
                      </a: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3701367"/>
                  </a:ext>
                </a:extLst>
              </a:tr>
              <a:tr h="32758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 [24.5-28.0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5 [26.3-29.0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9705023"/>
                  </a:ext>
                </a:extLst>
              </a:tr>
              <a:tr h="32758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diabetic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3 [27.3-28.9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2 [27.4-29.2]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4146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3770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558805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charset="0"/>
                <a:ea typeface="Arial" charset="0"/>
                <a:cs typeface="Arial" charset="0"/>
              </a:rPr>
              <a:t>Supplemental file 3 </a:t>
            </a:r>
            <a:r>
              <a:rPr kumimoji="1" lang="en-US" altLang="ja-JP" sz="1200" dirty="0">
                <a:latin typeface="Arial" charset="0"/>
                <a:ea typeface="Arial" charset="0"/>
                <a:cs typeface="Arial" charset="0"/>
              </a:rPr>
              <a:t>: </a:t>
            </a:r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The proportion of neutrophils in the blood samples and the neutrophil counts in the peripheral blood before and after operation in each group.</a:t>
            </a:r>
            <a:endParaRPr lang="ja-JP" altLang="ja-JP" sz="12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5662310"/>
              </p:ext>
            </p:extLst>
          </p:nvPr>
        </p:nvGraphicFramePr>
        <p:xfrm>
          <a:off x="257584" y="1178263"/>
          <a:ext cx="5990815" cy="181799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77780">
                  <a:extLst>
                    <a:ext uri="{9D8B030D-6E8A-4147-A177-3AD203B41FA5}">
                      <a16:colId xmlns:a16="http://schemas.microsoft.com/office/drawing/2014/main" xmlns="" val="2537526748"/>
                    </a:ext>
                  </a:extLst>
                </a:gridCol>
                <a:gridCol w="1741780">
                  <a:extLst>
                    <a:ext uri="{9D8B030D-6E8A-4147-A177-3AD203B41FA5}">
                      <a16:colId xmlns:a16="http://schemas.microsoft.com/office/drawing/2014/main" xmlns="" val="2826040909"/>
                    </a:ext>
                  </a:extLst>
                </a:gridCol>
                <a:gridCol w="1871255">
                  <a:extLst>
                    <a:ext uri="{9D8B030D-6E8A-4147-A177-3AD203B41FA5}">
                      <a16:colId xmlns:a16="http://schemas.microsoft.com/office/drawing/2014/main" xmlns="" val="1379018473"/>
                    </a:ext>
                  </a:extLst>
                </a:gridCol>
              </a:tblGrid>
              <a:tr h="438710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Before</a:t>
                      </a:r>
                      <a:r>
                        <a:rPr lang="ja-JP" altLang="en-US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peration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ercentage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of 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neutrophils 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Neutrophil</a:t>
                      </a:r>
                    </a:p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count (/</a:t>
                      </a:r>
                      <a:r>
                        <a:rPr lang="en-US" altLang="ja-JP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μl</a:t>
                      </a:r>
                      <a:r>
                        <a:rPr lang="ja-JP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sz="12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84786750"/>
                  </a:ext>
                </a:extLst>
              </a:tr>
              <a:tr h="3448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insulin (DM</a:t>
                      </a: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(ref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10.6 [8.3-17.9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359 [232-472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94979208"/>
                  </a:ext>
                </a:extLst>
              </a:tr>
              <a:tr h="3448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rt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10.8 [6.7-30.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254 [213-295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3701367"/>
                  </a:ext>
                </a:extLst>
              </a:tr>
              <a:tr h="3448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16.2 [8.3-26.0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356 [269-534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9705023"/>
                  </a:ext>
                </a:extLst>
              </a:tr>
              <a:tr h="34482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diabetic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7.7 [5.5-9.1]</a:t>
                      </a:r>
                      <a:r>
                        <a:rPr lang="ja-JP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＊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310 [214-399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4146012"/>
                  </a:ext>
                </a:extLst>
              </a:tr>
            </a:tbl>
          </a:graphicData>
        </a:graphic>
      </p:graphicFrame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8890331"/>
              </p:ext>
            </p:extLst>
          </p:nvPr>
        </p:nvGraphicFramePr>
        <p:xfrm>
          <a:off x="257584" y="3318853"/>
          <a:ext cx="5990815" cy="181800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77780">
                  <a:extLst>
                    <a:ext uri="{9D8B030D-6E8A-4147-A177-3AD203B41FA5}">
                      <a16:colId xmlns:a16="http://schemas.microsoft.com/office/drawing/2014/main" xmlns="" val="2537526748"/>
                    </a:ext>
                  </a:extLst>
                </a:gridCol>
                <a:gridCol w="1741780">
                  <a:extLst>
                    <a:ext uri="{9D8B030D-6E8A-4147-A177-3AD203B41FA5}">
                      <a16:colId xmlns:a16="http://schemas.microsoft.com/office/drawing/2014/main" xmlns="" val="2826040909"/>
                    </a:ext>
                  </a:extLst>
                </a:gridCol>
                <a:gridCol w="1871255">
                  <a:extLst>
                    <a:ext uri="{9D8B030D-6E8A-4147-A177-3AD203B41FA5}">
                      <a16:colId xmlns:a16="http://schemas.microsoft.com/office/drawing/2014/main" xmlns="" val="1379018473"/>
                    </a:ext>
                  </a:extLst>
                </a:gridCol>
              </a:tblGrid>
              <a:tr h="449786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fter</a:t>
                      </a:r>
                      <a:r>
                        <a:rPr lang="ja-JP" altLang="en-US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peration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Percentage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of 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neutrophils 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Neutrophil</a:t>
                      </a:r>
                    </a:p>
                    <a:p>
                      <a:pPr algn="ctr" fontAlgn="b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count (/</a:t>
                      </a:r>
                      <a:r>
                        <a:rPr lang="en-US" altLang="ja-JP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μl</a:t>
                      </a:r>
                      <a:r>
                        <a:rPr lang="ja-JP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）</a:t>
                      </a:r>
                      <a:endParaRPr lang="en-US" altLang="ja-JP" sz="12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84786750"/>
                  </a:ext>
                </a:extLst>
              </a:tr>
              <a:tr h="34205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insulin (DM</a:t>
                      </a:r>
                      <a:r>
                        <a:rPr lang="en-US" sz="1200" b="0" kern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(ref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24.0 [13.6-50.6]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622 [422-1055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94979208"/>
                  </a:ext>
                </a:extLst>
              </a:tr>
              <a:tr h="34205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rt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32.2 [15.0-57.7]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458 [223-872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3701367"/>
                  </a:ext>
                </a:extLst>
              </a:tr>
              <a:tr h="34205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-term insulin (DM)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15.4 [10.0-20.2]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392 [191-855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9705023"/>
                  </a:ext>
                </a:extLst>
              </a:tr>
              <a:tr h="34205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diabetic</a:t>
                      </a:r>
                      <a:endParaRPr lang="ja-JP" sz="12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</a:rPr>
                        <a:t>22.0 [17.0-32.5]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678 [598-946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50" charset="-128"/>
                          <a:cs typeface="Arial" panose="020B0604020202020204" pitchFamily="34" charset="0"/>
                        </a:rPr>
                        <a:t>]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4146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37990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464686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le 4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utrophil count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cording to the number of phagocytosis beads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the total count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agocytosed beads before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d after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peration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 each group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124124" y="1226205"/>
            <a:ext cx="213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ope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124124" y="4753789"/>
            <a:ext cx="213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fter ope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665" y="1227660"/>
            <a:ext cx="6553200" cy="32004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15" y="4741337"/>
            <a:ext cx="65405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4282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055" y="1361781"/>
            <a:ext cx="1505050" cy="1247939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52212" y="1361781"/>
            <a:ext cx="1505050" cy="1247939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05159" y="1361781"/>
            <a:ext cx="1505050" cy="1247939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58107" y="1361781"/>
            <a:ext cx="1505050" cy="1247939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498312" y="1492906"/>
            <a:ext cx="116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No insulin (DM)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960976" y="1400572"/>
            <a:ext cx="1002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hort-term</a:t>
            </a: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(D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1055" y="3066899"/>
            <a:ext cx="1537697" cy="1275009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19565" y="3066899"/>
            <a:ext cx="1537697" cy="1275009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83395" y="3066899"/>
            <a:ext cx="1537697" cy="1275009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47225" y="3066899"/>
            <a:ext cx="1537697" cy="1275009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189862" y="982074"/>
            <a:ext cx="1317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ope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408028" y="1392629"/>
            <a:ext cx="1002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ng-term</a:t>
            </a: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(D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868872" y="1403389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n-diabeti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05372" y="3201606"/>
            <a:ext cx="116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No insulin (DM)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968036" y="3109272"/>
            <a:ext cx="1002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hort-term</a:t>
            </a: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(D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96922" y="2690774"/>
            <a:ext cx="1191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fter ope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415088" y="3101329"/>
            <a:ext cx="1002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ng-term</a:t>
            </a: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sulin (D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875932" y="3112089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n-diabeti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0" y="268565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le 5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OS image of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flowcytometry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each group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38336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3</TotalTime>
  <Words>387</Words>
  <Application>Microsoft Macintosh PowerPoint</Application>
  <PresentationFormat>A4 210x297 mm</PresentationFormat>
  <Paragraphs>112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4" baseType="lpstr">
      <vt:lpstr>Calibri</vt:lpstr>
      <vt:lpstr>Calibri Light</vt:lpstr>
      <vt:lpstr>MS PGothic</vt:lpstr>
      <vt:lpstr>Yu Gothic</vt:lpstr>
      <vt:lpstr>游ゴシック</vt:lpstr>
      <vt:lpstr>游ゴシック Light</vt:lpstr>
      <vt:lpstr>游明朝</vt:lpstr>
      <vt:lpstr>Arial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本 大地</dc:creator>
  <cp:lastModifiedBy>藤本 大地</cp:lastModifiedBy>
  <cp:revision>79</cp:revision>
  <dcterms:created xsi:type="dcterms:W3CDTF">2019-08-07T10:08:27Z</dcterms:created>
  <dcterms:modified xsi:type="dcterms:W3CDTF">2020-08-28T04:10:23Z</dcterms:modified>
</cp:coreProperties>
</file>